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6" r:id="rId5"/>
    <p:sldId id="257" r:id="rId6"/>
    <p:sldId id="258" r:id="rId7"/>
    <p:sldId id="260" r:id="rId8"/>
    <p:sldId id="259" r:id="rId9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20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C7CC458-0351-4903-905E-26FBD78EC4B1}" v="10" dt="2020-09-08T16:45:10.72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62" d="100"/>
          <a:sy n="62" d="100"/>
        </p:scale>
        <p:origin x="2405" y="58"/>
      </p:cViewPr>
      <p:guideLst>
        <p:guide orient="horz" pos="2880"/>
        <p:guide pos="220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microsoft.com/office/2015/10/relationships/revisionInfo" Target="revisionInfo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N:\2017%20&#50672;&#44396;&#45236;&#50857;\&#44608;&#44221;&#48120;\&#49892;&#54744;%20DATA\SNU-484\SNU-484(&#51116;&#54788;&#49457;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Nanotox1\Desktop\SNU-620(&#51116;&#54788;&#49457;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SNU-484</a:t>
            </a:r>
            <a:endParaRPr lang="ko-KR"/>
          </a:p>
        </c:rich>
      </c:tx>
      <c:layout>
        <c:manualLayout>
          <c:xMode val="edge"/>
          <c:yMode val="edge"/>
          <c:x val="0.40142578011081947"/>
          <c:y val="3.411992096767013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5212948381452316"/>
          <c:y val="9.8751499482683594E-2"/>
          <c:w val="0.70092621755613882"/>
          <c:h val="0.71053417377857664"/>
        </c:manualLayout>
      </c:layout>
      <c:scatterChart>
        <c:scatterStyle val="smoothMarker"/>
        <c:varyColors val="0"/>
        <c:ser>
          <c:idx val="0"/>
          <c:order val="0"/>
          <c:tx>
            <c:v>Male</c:v>
          </c:tx>
          <c:spPr>
            <a:ln w="9525">
              <a:solidFill>
                <a:sysClr val="windowText" lastClr="000000"/>
              </a:solidFill>
            </a:ln>
          </c:spPr>
          <c:marker>
            <c:symbol val="squar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1!$R$11:$AR$11</c:f>
                <c:numCache>
                  <c:formatCode>General</c:formatCode>
                  <c:ptCount val="27"/>
                  <c:pt idx="1">
                    <c:v>27.689288808609671</c:v>
                  </c:pt>
                  <c:pt idx="2">
                    <c:v>58.04281149200348</c:v>
                  </c:pt>
                  <c:pt idx="3">
                    <c:v>118.46262072192917</c:v>
                  </c:pt>
                  <c:pt idx="4">
                    <c:v>208.06287442419716</c:v>
                  </c:pt>
                  <c:pt idx="5">
                    <c:v>485.87829189247265</c:v>
                  </c:pt>
                  <c:pt idx="6">
                    <c:v>793.78261189728448</c:v>
                  </c:pt>
                  <c:pt idx="7">
                    <c:v>1101.4934826917004</c:v>
                  </c:pt>
                  <c:pt idx="8">
                    <c:v>1943.9274575852282</c:v>
                  </c:pt>
                  <c:pt idx="9">
                    <c:v>2277.8957480974846</c:v>
                  </c:pt>
                </c:numCache>
              </c:numRef>
            </c:plus>
            <c:minus>
              <c:numRef>
                <c:f>Sheet1!$R$11:$AR$11</c:f>
                <c:numCache>
                  <c:formatCode>General</c:formatCode>
                  <c:ptCount val="27"/>
                  <c:pt idx="1">
                    <c:v>27.689288808609671</c:v>
                  </c:pt>
                  <c:pt idx="2">
                    <c:v>58.04281149200348</c:v>
                  </c:pt>
                  <c:pt idx="3">
                    <c:v>118.46262072192917</c:v>
                  </c:pt>
                  <c:pt idx="4">
                    <c:v>208.06287442419716</c:v>
                  </c:pt>
                  <c:pt idx="5">
                    <c:v>485.87829189247265</c:v>
                  </c:pt>
                  <c:pt idx="6">
                    <c:v>793.78261189728448</c:v>
                  </c:pt>
                  <c:pt idx="7">
                    <c:v>1101.4934826917004</c:v>
                  </c:pt>
                  <c:pt idx="8">
                    <c:v>1943.9274575852282</c:v>
                  </c:pt>
                  <c:pt idx="9">
                    <c:v>2277.8957480974846</c:v>
                  </c:pt>
                </c:numCache>
              </c:numRef>
            </c:minus>
          </c:errBars>
          <c:xVal>
            <c:numRef>
              <c:f>Sheet1!$R$4:$AR$4</c:f>
              <c:numCache>
                <c:formatCode>General</c:formatCode>
                <c:ptCount val="27"/>
                <c:pt idx="0">
                  <c:v>0</c:v>
                </c:pt>
                <c:pt idx="1">
                  <c:v>9</c:v>
                </c:pt>
                <c:pt idx="2">
                  <c:v>12</c:v>
                </c:pt>
                <c:pt idx="3">
                  <c:v>14</c:v>
                </c:pt>
                <c:pt idx="4">
                  <c:v>16</c:v>
                </c:pt>
                <c:pt idx="5">
                  <c:v>19</c:v>
                </c:pt>
                <c:pt idx="6">
                  <c:v>21</c:v>
                </c:pt>
                <c:pt idx="7">
                  <c:v>23</c:v>
                </c:pt>
                <c:pt idx="8">
                  <c:v>26</c:v>
                </c:pt>
                <c:pt idx="9">
                  <c:v>28</c:v>
                </c:pt>
              </c:numCache>
            </c:numRef>
          </c:xVal>
          <c:yVal>
            <c:numRef>
              <c:f>Sheet1!$R$10:$AR$10</c:f>
              <c:numCache>
                <c:formatCode>General</c:formatCode>
                <c:ptCount val="27"/>
                <c:pt idx="0">
                  <c:v>0</c:v>
                </c:pt>
                <c:pt idx="1">
                  <c:v>65.219034000000022</c:v>
                </c:pt>
                <c:pt idx="2">
                  <c:v>117.66933440000003</c:v>
                </c:pt>
                <c:pt idx="3">
                  <c:v>190.48793930000008</c:v>
                </c:pt>
                <c:pt idx="4">
                  <c:v>289.83443719999997</c:v>
                </c:pt>
                <c:pt idx="5">
                  <c:v>512.80318569999997</c:v>
                </c:pt>
                <c:pt idx="6">
                  <c:v>825.57195750000005</c:v>
                </c:pt>
                <c:pt idx="7">
                  <c:v>1150.4610759000002</c:v>
                </c:pt>
                <c:pt idx="8">
                  <c:v>2131.0450613999997</c:v>
                </c:pt>
                <c:pt idx="9">
                  <c:v>2415.05452290000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EBCE-49CB-BAD4-0E759D034F16}"/>
            </c:ext>
          </c:extLst>
        </c:ser>
        <c:ser>
          <c:idx val="1"/>
          <c:order val="1"/>
          <c:tx>
            <c:v>Female</c:v>
          </c:tx>
          <c:spPr>
            <a:ln w="9525">
              <a:solidFill>
                <a:sysClr val="windowText" lastClr="000000"/>
              </a:solidFill>
            </a:ln>
          </c:spPr>
          <c:marker>
            <c:symbol val="square"/>
            <c:size val="7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1!$R$18:$AR$18</c:f>
                <c:numCache>
                  <c:formatCode>General</c:formatCode>
                  <c:ptCount val="27"/>
                  <c:pt idx="1">
                    <c:v>24.817516759698574</c:v>
                  </c:pt>
                  <c:pt idx="2">
                    <c:v>42.654159797909998</c:v>
                  </c:pt>
                  <c:pt idx="3">
                    <c:v>83.456541176563135</c:v>
                  </c:pt>
                  <c:pt idx="4">
                    <c:v>202.48542172267923</c:v>
                  </c:pt>
                  <c:pt idx="5">
                    <c:v>288.11242606328665</c:v>
                  </c:pt>
                  <c:pt idx="6">
                    <c:v>505.05874819442391</c:v>
                  </c:pt>
                  <c:pt idx="7">
                    <c:v>940.19359311150652</c:v>
                  </c:pt>
                  <c:pt idx="8">
                    <c:v>1442.1950387314685</c:v>
                  </c:pt>
                  <c:pt idx="9">
                    <c:v>1805.3155553624758</c:v>
                  </c:pt>
                </c:numCache>
              </c:numRef>
            </c:plus>
            <c:minus>
              <c:numRef>
                <c:f>Sheet1!$R$18:$AR$18</c:f>
                <c:numCache>
                  <c:formatCode>General</c:formatCode>
                  <c:ptCount val="27"/>
                  <c:pt idx="1">
                    <c:v>24.817516759698574</c:v>
                  </c:pt>
                  <c:pt idx="2">
                    <c:v>42.654159797909998</c:v>
                  </c:pt>
                  <c:pt idx="3">
                    <c:v>83.456541176563135</c:v>
                  </c:pt>
                  <c:pt idx="4">
                    <c:v>202.48542172267923</c:v>
                  </c:pt>
                  <c:pt idx="5">
                    <c:v>288.11242606328665</c:v>
                  </c:pt>
                  <c:pt idx="6">
                    <c:v>505.05874819442391</c:v>
                  </c:pt>
                  <c:pt idx="7">
                    <c:v>940.19359311150652</c:v>
                  </c:pt>
                  <c:pt idx="8">
                    <c:v>1442.1950387314685</c:v>
                  </c:pt>
                  <c:pt idx="9">
                    <c:v>1805.3155553624758</c:v>
                  </c:pt>
                </c:numCache>
              </c:numRef>
            </c:minus>
          </c:errBars>
          <c:xVal>
            <c:numRef>
              <c:f>Sheet1!$R$4:$AR$4</c:f>
              <c:numCache>
                <c:formatCode>General</c:formatCode>
                <c:ptCount val="27"/>
                <c:pt idx="0">
                  <c:v>0</c:v>
                </c:pt>
                <c:pt idx="1">
                  <c:v>9</c:v>
                </c:pt>
                <c:pt idx="2">
                  <c:v>12</c:v>
                </c:pt>
                <c:pt idx="3">
                  <c:v>14</c:v>
                </c:pt>
                <c:pt idx="4">
                  <c:v>16</c:v>
                </c:pt>
                <c:pt idx="5">
                  <c:v>19</c:v>
                </c:pt>
                <c:pt idx="6">
                  <c:v>21</c:v>
                </c:pt>
                <c:pt idx="7">
                  <c:v>23</c:v>
                </c:pt>
                <c:pt idx="8">
                  <c:v>26</c:v>
                </c:pt>
                <c:pt idx="9">
                  <c:v>28</c:v>
                </c:pt>
              </c:numCache>
            </c:numRef>
          </c:xVal>
          <c:yVal>
            <c:numRef>
              <c:f>Sheet1!$R$17:$AR$17</c:f>
              <c:numCache>
                <c:formatCode>General</c:formatCode>
                <c:ptCount val="27"/>
                <c:pt idx="0">
                  <c:v>0</c:v>
                </c:pt>
                <c:pt idx="1">
                  <c:v>43.712981666666643</c:v>
                </c:pt>
                <c:pt idx="2">
                  <c:v>81.431479375000023</c:v>
                </c:pt>
                <c:pt idx="3">
                  <c:v>156.428264625</c:v>
                </c:pt>
                <c:pt idx="4">
                  <c:v>287.71087362499998</c:v>
                </c:pt>
                <c:pt idx="5">
                  <c:v>374.80581709999996</c:v>
                </c:pt>
                <c:pt idx="6">
                  <c:v>606.71495535000008</c:v>
                </c:pt>
                <c:pt idx="7">
                  <c:v>1015.7239518</c:v>
                </c:pt>
                <c:pt idx="8">
                  <c:v>1634.1356722</c:v>
                </c:pt>
                <c:pt idx="9">
                  <c:v>2246.476354900000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EBCE-49CB-BAD4-0E759D034F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5649920"/>
        <c:axId val="135701248"/>
      </c:scatterChart>
      <c:valAx>
        <c:axId val="135649920"/>
        <c:scaling>
          <c:orientation val="minMax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ays</a:t>
                </a:r>
              </a:p>
            </c:rich>
          </c:tx>
          <c:layout>
            <c:manualLayout>
              <c:xMode val="edge"/>
              <c:yMode val="edge"/>
              <c:x val="0.51584434424272141"/>
              <c:y val="0.8822726961961491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31750">
            <a:solidFill>
              <a:schemeClr val="tx1"/>
            </a:solidFill>
          </a:ln>
        </c:spPr>
        <c:crossAx val="135701248"/>
        <c:crosses val="autoZero"/>
        <c:crossBetween val="midCat"/>
        <c:majorUnit val="5"/>
      </c:valAx>
      <c:valAx>
        <c:axId val="135701248"/>
        <c:scaling>
          <c:orientation val="minMax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umor volume(mm3)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1.1081073199183439E-2"/>
              <c:y val="9.9747228571998817E-2"/>
            </c:manualLayout>
          </c:layout>
          <c:overlay val="0"/>
        </c:title>
        <c:numFmt formatCode="#,##0_);[Red]\(#,##0\)" sourceLinked="0"/>
        <c:majorTickMark val="out"/>
        <c:minorTickMark val="none"/>
        <c:tickLblPos val="nextTo"/>
        <c:spPr>
          <a:ln w="31750">
            <a:solidFill>
              <a:sysClr val="windowText" lastClr="000000"/>
            </a:solidFill>
          </a:ln>
        </c:spPr>
        <c:crossAx val="135649920"/>
        <c:crosses val="autoZero"/>
        <c:crossBetween val="midCat"/>
        <c:majorUnit val="1000"/>
      </c:valAx>
    </c:plotArea>
    <c:legend>
      <c:legendPos val="r"/>
      <c:layout>
        <c:manualLayout>
          <c:xMode val="edge"/>
          <c:yMode val="edge"/>
          <c:x val="0.26796617089530478"/>
          <c:y val="0.55676188516977054"/>
          <c:w val="0.29942765304796648"/>
          <c:h val="0.1598676727909012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200"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altLang="ko-KR" sz="1400" dirty="0"/>
              <a:t>SNU-620</a:t>
            </a:r>
            <a:endParaRPr lang="ko-KR" altLang="en-US" sz="1400" dirty="0"/>
          </a:p>
        </c:rich>
      </c:tx>
      <c:layout>
        <c:manualLayout>
          <c:xMode val="edge"/>
          <c:yMode val="edge"/>
          <c:x val="0.43967004873854598"/>
          <c:y val="3.96830907676924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3753791849214828"/>
          <c:y val="0.10007811632040885"/>
          <c:w val="0.71386482419827779"/>
          <c:h val="0.6504898761248757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T$111</c:f>
              <c:strCache>
                <c:ptCount val="1"/>
                <c:pt idx="0">
                  <c:v>Female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V$98:$AG$98</c:f>
                <c:numCache>
                  <c:formatCode>General</c:formatCode>
                  <c:ptCount val="12"/>
                  <c:pt idx="0">
                    <c:v>20.814831731244027</c:v>
                  </c:pt>
                  <c:pt idx="1">
                    <c:v>71.792931894442063</c:v>
                  </c:pt>
                  <c:pt idx="2">
                    <c:v>68.791051598300143</c:v>
                  </c:pt>
                  <c:pt idx="3">
                    <c:v>85.685941087205222</c:v>
                  </c:pt>
                  <c:pt idx="4">
                    <c:v>127.17716068539971</c:v>
                  </c:pt>
                  <c:pt idx="5">
                    <c:v>174.63404593606595</c:v>
                  </c:pt>
                  <c:pt idx="6">
                    <c:v>282.68498014574453</c:v>
                  </c:pt>
                  <c:pt idx="7">
                    <c:v>327.55974722178547</c:v>
                  </c:pt>
                  <c:pt idx="8">
                    <c:v>393.65023434516075</c:v>
                  </c:pt>
                  <c:pt idx="9">
                    <c:v>459.48856133749405</c:v>
                  </c:pt>
                  <c:pt idx="10">
                    <c:v>499.13106161274555</c:v>
                  </c:pt>
                  <c:pt idx="11">
                    <c:v>425.4354984405196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Sheet1!$V$89:$AF$89</c:f>
              <c:numCache>
                <c:formatCode>General</c:formatCode>
                <c:ptCount val="11"/>
                <c:pt idx="0">
                  <c:v>1</c:v>
                </c:pt>
                <c:pt idx="1">
                  <c:v>3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3</c:v>
                </c:pt>
                <c:pt idx="6">
                  <c:v>15</c:v>
                </c:pt>
                <c:pt idx="7">
                  <c:v>17</c:v>
                </c:pt>
                <c:pt idx="8">
                  <c:v>20</c:v>
                </c:pt>
                <c:pt idx="9">
                  <c:v>22</c:v>
                </c:pt>
                <c:pt idx="10">
                  <c:v>24</c:v>
                </c:pt>
              </c:numCache>
            </c:numRef>
          </c:xVal>
          <c:yVal>
            <c:numRef>
              <c:f>Sheet1!$V$97:$AF$97</c:f>
              <c:numCache>
                <c:formatCode>General</c:formatCode>
                <c:ptCount val="11"/>
                <c:pt idx="0">
                  <c:v>86.581999999999994</c:v>
                </c:pt>
                <c:pt idx="1">
                  <c:v>132.88800000000001</c:v>
                </c:pt>
                <c:pt idx="2">
                  <c:v>146.03400000000002</c:v>
                </c:pt>
                <c:pt idx="3">
                  <c:v>156.51</c:v>
                </c:pt>
                <c:pt idx="4">
                  <c:v>204.62000000000003</c:v>
                </c:pt>
                <c:pt idx="5">
                  <c:v>276.7</c:v>
                </c:pt>
                <c:pt idx="6">
                  <c:v>375.14</c:v>
                </c:pt>
                <c:pt idx="7">
                  <c:v>399.06</c:v>
                </c:pt>
                <c:pt idx="8">
                  <c:v>492.32</c:v>
                </c:pt>
                <c:pt idx="9">
                  <c:v>572.93999999999994</c:v>
                </c:pt>
                <c:pt idx="10">
                  <c:v>612.450000000000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72B-45CA-A247-0F57FC796DD6}"/>
            </c:ext>
          </c:extLst>
        </c:ser>
        <c:ser>
          <c:idx val="1"/>
          <c:order val="1"/>
          <c:tx>
            <c:strRef>
              <c:f>Sheet1!$T$120</c:f>
              <c:strCache>
                <c:ptCount val="1"/>
                <c:pt idx="0">
                  <c:v>Male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V$107:$AG$107</c:f>
                <c:numCache>
                  <c:formatCode>General</c:formatCode>
                  <c:ptCount val="12"/>
                  <c:pt idx="0">
                    <c:v>20.403431900867389</c:v>
                  </c:pt>
                  <c:pt idx="1">
                    <c:v>26.086101663529547</c:v>
                  </c:pt>
                  <c:pt idx="2">
                    <c:v>30.621438568427848</c:v>
                  </c:pt>
                  <c:pt idx="3">
                    <c:v>36.257286623978473</c:v>
                  </c:pt>
                  <c:pt idx="4">
                    <c:v>34.620261890016515</c:v>
                  </c:pt>
                  <c:pt idx="5">
                    <c:v>2.9698484809846755</c:v>
                  </c:pt>
                  <c:pt idx="6">
                    <c:v>22.795248042812268</c:v>
                  </c:pt>
                  <c:pt idx="7">
                    <c:v>0.42426406871192451</c:v>
                  </c:pt>
                  <c:pt idx="8">
                    <c:v>3.5355339059327378</c:v>
                  </c:pt>
                  <c:pt idx="9">
                    <c:v>30.617723625378098</c:v>
                  </c:pt>
                  <c:pt idx="10">
                    <c:v>20.788939366884328</c:v>
                  </c:pt>
                  <c:pt idx="11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Sheet1!$V$89:$AF$89</c:f>
              <c:numCache>
                <c:formatCode>General</c:formatCode>
                <c:ptCount val="11"/>
                <c:pt idx="0">
                  <c:v>1</c:v>
                </c:pt>
                <c:pt idx="1">
                  <c:v>3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3</c:v>
                </c:pt>
                <c:pt idx="6">
                  <c:v>15</c:v>
                </c:pt>
                <c:pt idx="7">
                  <c:v>17</c:v>
                </c:pt>
                <c:pt idx="8">
                  <c:v>20</c:v>
                </c:pt>
                <c:pt idx="9">
                  <c:v>22</c:v>
                </c:pt>
                <c:pt idx="10">
                  <c:v>24</c:v>
                </c:pt>
              </c:numCache>
            </c:numRef>
          </c:xVal>
          <c:yVal>
            <c:numRef>
              <c:f>Sheet1!$V$106:$AF$106</c:f>
              <c:numCache>
                <c:formatCode>General</c:formatCode>
                <c:ptCount val="11"/>
                <c:pt idx="0">
                  <c:v>64.256666666666675</c:v>
                </c:pt>
                <c:pt idx="1">
                  <c:v>66.900000000000006</c:v>
                </c:pt>
                <c:pt idx="2">
                  <c:v>99.75</c:v>
                </c:pt>
                <c:pt idx="3">
                  <c:v>108.11666666666667</c:v>
                </c:pt>
                <c:pt idx="4">
                  <c:v>135.74666666666667</c:v>
                </c:pt>
                <c:pt idx="5">
                  <c:v>171.2</c:v>
                </c:pt>
                <c:pt idx="6">
                  <c:v>200.33333333333334</c:v>
                </c:pt>
                <c:pt idx="7">
                  <c:v>198.60000000000002</c:v>
                </c:pt>
                <c:pt idx="8">
                  <c:v>256.2</c:v>
                </c:pt>
                <c:pt idx="9">
                  <c:v>276.64999999999998</c:v>
                </c:pt>
                <c:pt idx="10">
                  <c:v>34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972B-45CA-A247-0F57FC796D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3655936"/>
        <c:axId val="173666304"/>
      </c:scatterChart>
      <c:valAx>
        <c:axId val="173655936"/>
        <c:scaling>
          <c:orientation val="minMax"/>
          <c:max val="25"/>
          <c:min val="0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en-US"/>
                  <a:t>Days</a:t>
                </a:r>
                <a:endParaRPr lang="ko-KR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3175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ko-KR"/>
          </a:p>
        </c:txPr>
        <c:crossAx val="173666304"/>
        <c:crosses val="autoZero"/>
        <c:crossBetween val="midCat"/>
        <c:majorUnit val="5"/>
      </c:valAx>
      <c:valAx>
        <c:axId val="17366630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Tumor volume (mm</a:t>
                </a:r>
                <a:r>
                  <a:rPr lang="en-US" baseline="30000"/>
                  <a:t>3</a:t>
                </a:r>
                <a:r>
                  <a:rPr lang="en-US"/>
                  <a:t>)</a:t>
                </a:r>
                <a:endParaRPr lang="ko-KR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#,##0_);\(#,##0\)" sourceLinked="0"/>
        <c:majorTickMark val="out"/>
        <c:minorTickMark val="none"/>
        <c:tickLblPos val="nextTo"/>
        <c:spPr>
          <a:noFill/>
          <a:ln w="3175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ko-KR"/>
          </a:p>
        </c:txPr>
        <c:crossAx val="17365593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1951999294764354"/>
          <c:y val="0.28219086768136875"/>
          <c:w val="0.32484615235988301"/>
          <c:h val="0.13879742528607933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ko-KR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6F9E-3D4F-4BBE-B10A-110CC84DE452}" type="datetimeFigureOut">
              <a:rPr lang="ko-KR" altLang="en-US" smtClean="0"/>
              <a:t>2021-0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5E20-3C0B-40D7-A01A-84F6BC430E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7613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6F9E-3D4F-4BBE-B10A-110CC84DE452}" type="datetimeFigureOut">
              <a:rPr lang="ko-KR" altLang="en-US" smtClean="0"/>
              <a:t>2021-0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5E20-3C0B-40D7-A01A-84F6BC430E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496009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6F9E-3D4F-4BBE-B10A-110CC84DE452}" type="datetimeFigureOut">
              <a:rPr lang="ko-KR" altLang="en-US" smtClean="0"/>
              <a:t>2021-0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5E20-3C0B-40D7-A01A-84F6BC430E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838029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6F9E-3D4F-4BBE-B10A-110CC84DE452}" type="datetimeFigureOut">
              <a:rPr lang="ko-KR" altLang="en-US" smtClean="0"/>
              <a:t>2021-0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5E20-3C0B-40D7-A01A-84F6BC430E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6223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6F9E-3D4F-4BBE-B10A-110CC84DE452}" type="datetimeFigureOut">
              <a:rPr lang="ko-KR" altLang="en-US" smtClean="0"/>
              <a:t>2021-0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5E20-3C0B-40D7-A01A-84F6BC430E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1329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6F9E-3D4F-4BBE-B10A-110CC84DE452}" type="datetimeFigureOut">
              <a:rPr lang="ko-KR" altLang="en-US" smtClean="0"/>
              <a:t>2021-01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5E20-3C0B-40D7-A01A-84F6BC430E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79146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6F9E-3D4F-4BBE-B10A-110CC84DE452}" type="datetimeFigureOut">
              <a:rPr lang="ko-KR" altLang="en-US" smtClean="0"/>
              <a:t>2021-01-0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5E20-3C0B-40D7-A01A-84F6BC430E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31242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6F9E-3D4F-4BBE-B10A-110CC84DE452}" type="datetimeFigureOut">
              <a:rPr lang="ko-KR" altLang="en-US" smtClean="0"/>
              <a:t>2021-01-0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5E20-3C0B-40D7-A01A-84F6BC430E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75215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6F9E-3D4F-4BBE-B10A-110CC84DE452}" type="datetimeFigureOut">
              <a:rPr lang="ko-KR" altLang="en-US" smtClean="0"/>
              <a:t>2021-01-0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5E20-3C0B-40D7-A01A-84F6BC430E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87190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6F9E-3D4F-4BBE-B10A-110CC84DE452}" type="datetimeFigureOut">
              <a:rPr lang="ko-KR" altLang="en-US" smtClean="0"/>
              <a:t>2021-01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5E20-3C0B-40D7-A01A-84F6BC430E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87204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6F9E-3D4F-4BBE-B10A-110CC84DE452}" type="datetimeFigureOut">
              <a:rPr lang="ko-KR" altLang="en-US" smtClean="0"/>
              <a:t>2021-01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5E20-3C0B-40D7-A01A-84F6BC430E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66924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D6F9E-3D4F-4BBE-B10A-110CC84DE452}" type="datetimeFigureOut">
              <a:rPr lang="ko-KR" altLang="en-US" smtClean="0"/>
              <a:t>2021-0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4D5E20-3C0B-40D7-A01A-84F6BC430E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35738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openxmlformats.org/officeDocument/2006/relationships/image" Target="../media/image15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12" Type="http://schemas.openxmlformats.org/officeDocument/2006/relationships/image" Target="../media/image14.png"/><Relationship Id="rId2" Type="http://schemas.openxmlformats.org/officeDocument/2006/relationships/image" Target="../media/image4.png"/><Relationship Id="rId16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openxmlformats.org/officeDocument/2006/relationships/image" Target="../media/image13.png"/><Relationship Id="rId5" Type="http://schemas.openxmlformats.org/officeDocument/2006/relationships/image" Target="../media/image7.png"/><Relationship Id="rId15" Type="http://schemas.openxmlformats.org/officeDocument/2006/relationships/image" Target="../media/image17.png"/><Relationship Id="rId10" Type="http://schemas.openxmlformats.org/officeDocument/2006/relationships/image" Target="../media/image12.png"/><Relationship Id="rId4" Type="http://schemas.openxmlformats.org/officeDocument/2006/relationships/image" Target="../media/image6.png"/><Relationship Id="rId9" Type="http://schemas.openxmlformats.org/officeDocument/2006/relationships/image" Target="../media/image11.png"/><Relationship Id="rId14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차트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47332189"/>
              </p:ext>
            </p:extLst>
          </p:nvPr>
        </p:nvGraphicFramePr>
        <p:xfrm>
          <a:off x="1605936" y="3674016"/>
          <a:ext cx="3429000" cy="26055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차트 2"/>
          <p:cNvGraphicFramePr/>
          <p:nvPr>
            <p:extLst>
              <p:ext uri="{D42A27DB-BD31-4B8C-83A1-F6EECF244321}">
                <p14:modId xmlns:p14="http://schemas.microsoft.com/office/powerpoint/2010/main" val="2959045370"/>
              </p:ext>
            </p:extLst>
          </p:nvPr>
        </p:nvGraphicFramePr>
        <p:xfrm>
          <a:off x="1664252" y="564572"/>
          <a:ext cx="3312368" cy="28803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948690" y="199742"/>
            <a:ext cx="351378" cy="36933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endParaRPr lang="en-US" altLang="ko-KR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10173" y="7132320"/>
            <a:ext cx="6576377" cy="1668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Tumor growth of diffuse-type gastric cancer cells</a:t>
            </a:r>
          </a:p>
          <a:p>
            <a:pPr>
              <a:lnSpc>
                <a:spcPct val="150000"/>
              </a:lnSpc>
            </a:pP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(A) SNU-620 (human female gastric cancer cell line, 5×10</a:t>
            </a:r>
            <a:r>
              <a:rPr lang="en-US" altLang="ko-K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 cells) and (B) SNU-484 (human male gastric cancer cell line, 1×10</a:t>
            </a:r>
            <a:r>
              <a:rPr lang="en-US" altLang="ko-K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 cells) cells were transplanted into female and male </a:t>
            </a:r>
            <a:r>
              <a:rPr lang="en-US" altLang="ko-KR" sz="1400" dirty="0" err="1">
                <a:latin typeface="Arial" panose="020B0604020202020204" pitchFamily="34" charset="0"/>
                <a:cs typeface="Arial" panose="020B0604020202020204" pitchFamily="34" charset="0"/>
              </a:rPr>
              <a:t>Ncr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 nude mice. </a:t>
            </a:r>
            <a:r>
              <a:rPr lang="en-US" altLang="ko-KR" sz="1400" kern="100" dirty="0">
                <a:latin typeface="Arial" panose="020B0604020202020204" pitchFamily="34" charset="0"/>
                <a:cs typeface="Arial" panose="020B0604020202020204" pitchFamily="34" charset="0"/>
              </a:rPr>
              <a:t>Data are presented as the mean ± S.D.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 (n=5/group)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65489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그룹 25"/>
          <p:cNvGrpSpPr/>
          <p:nvPr/>
        </p:nvGrpSpPr>
        <p:grpSpPr>
          <a:xfrm>
            <a:off x="1016768" y="1913872"/>
            <a:ext cx="4892988" cy="1935364"/>
            <a:chOff x="1028198" y="1971022"/>
            <a:chExt cx="4892988" cy="1935364"/>
          </a:xfrm>
        </p:grpSpPr>
        <p:pic>
          <p:nvPicPr>
            <p:cNvPr id="2" name="Picture 2" descr="D:\느시\HYUN\할미새사촌\Data\2017젠더_위암(승연)\180104_12종세포확인(재)\2018-01-05_14-29-53 (1)\2018-01-05_14-29-53_8bit.pn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800" t="45892" r="13345" b="39573"/>
            <a:stretch/>
          </p:blipFill>
          <p:spPr bwMode="auto">
            <a:xfrm>
              <a:off x="1870836" y="2599534"/>
              <a:ext cx="3154680" cy="361885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TextBox 2"/>
            <p:cNvSpPr txBox="1"/>
            <p:nvPr/>
          </p:nvSpPr>
          <p:spPr>
            <a:xfrm>
              <a:off x="1109372" y="3078148"/>
              <a:ext cx="74697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600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el-GR" altLang="ko-KR" sz="16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155092" y="2608061"/>
              <a:ext cx="6841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600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el-GR" altLang="ko-KR" sz="1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028198" y="3567832"/>
              <a:ext cx="8318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altLang="ko-KR" sz="16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16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9372165">
              <a:off x="1735489" y="2006124"/>
              <a:ext cx="1224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/>
                <a:t>NCI-N87</a:t>
              </a:r>
              <a:endParaRPr lang="ko-KR" altLang="en-US" sz="1200" dirty="0"/>
            </a:p>
          </p:txBody>
        </p:sp>
        <p:sp>
          <p:nvSpPr>
            <p:cNvPr id="9" name="TextBox 8"/>
            <p:cNvSpPr txBox="1"/>
            <p:nvPr/>
          </p:nvSpPr>
          <p:spPr>
            <a:xfrm rot="19372165">
              <a:off x="1983035" y="2006124"/>
              <a:ext cx="1224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/>
                <a:t>SNU-484</a:t>
              </a:r>
              <a:endParaRPr lang="ko-KR" altLang="en-US" sz="1200" dirty="0"/>
            </a:p>
          </p:txBody>
        </p:sp>
        <p:sp>
          <p:nvSpPr>
            <p:cNvPr id="10" name="TextBox 9"/>
            <p:cNvSpPr txBox="1"/>
            <p:nvPr/>
          </p:nvSpPr>
          <p:spPr>
            <a:xfrm rot="19372165">
              <a:off x="2248501" y="1987470"/>
              <a:ext cx="1224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/>
                <a:t>SNU-1</a:t>
              </a:r>
              <a:endParaRPr lang="ko-KR" altLang="en-US" sz="1200" dirty="0"/>
            </a:p>
          </p:txBody>
        </p:sp>
        <p:sp>
          <p:nvSpPr>
            <p:cNvPr id="11" name="TextBox 10"/>
            <p:cNvSpPr txBox="1"/>
            <p:nvPr/>
          </p:nvSpPr>
          <p:spPr>
            <a:xfrm rot="19372165">
              <a:off x="2527854" y="1989676"/>
              <a:ext cx="1224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/>
                <a:t>SNU-638</a:t>
              </a:r>
              <a:endParaRPr lang="ko-KR" altLang="en-US" sz="1200" dirty="0"/>
            </a:p>
          </p:txBody>
        </p:sp>
        <p:sp>
          <p:nvSpPr>
            <p:cNvPr id="12" name="TextBox 11"/>
            <p:cNvSpPr txBox="1"/>
            <p:nvPr/>
          </p:nvSpPr>
          <p:spPr>
            <a:xfrm rot="19372165">
              <a:off x="2775400" y="1989676"/>
              <a:ext cx="1224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/>
                <a:t>KATOIII</a:t>
              </a:r>
              <a:endParaRPr lang="ko-KR" altLang="en-US" sz="1200" dirty="0"/>
            </a:p>
          </p:txBody>
        </p:sp>
        <p:sp>
          <p:nvSpPr>
            <p:cNvPr id="13" name="TextBox 12"/>
            <p:cNvSpPr txBox="1"/>
            <p:nvPr/>
          </p:nvSpPr>
          <p:spPr>
            <a:xfrm rot="19372165">
              <a:off x="3040866" y="1971022"/>
              <a:ext cx="1224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/>
                <a:t>MKN-1</a:t>
              </a:r>
              <a:endParaRPr lang="ko-KR" altLang="en-US" sz="1200" dirty="0"/>
            </a:p>
          </p:txBody>
        </p:sp>
        <p:sp>
          <p:nvSpPr>
            <p:cNvPr id="14" name="TextBox 13"/>
            <p:cNvSpPr txBox="1"/>
            <p:nvPr/>
          </p:nvSpPr>
          <p:spPr>
            <a:xfrm rot="19372165">
              <a:off x="4697050" y="1971022"/>
              <a:ext cx="1224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/>
                <a:t>SNU-5</a:t>
              </a:r>
              <a:endParaRPr lang="ko-KR" altLang="en-US" sz="1200" dirty="0"/>
            </a:p>
          </p:txBody>
        </p:sp>
        <p:sp>
          <p:nvSpPr>
            <p:cNvPr id="15" name="TextBox 14"/>
            <p:cNvSpPr txBox="1"/>
            <p:nvPr/>
          </p:nvSpPr>
          <p:spPr>
            <a:xfrm rot="19372165">
              <a:off x="3328898" y="1989676"/>
              <a:ext cx="1224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/>
                <a:t>MKN-28</a:t>
              </a:r>
              <a:endParaRPr lang="ko-KR" altLang="en-US" sz="1200" dirty="0"/>
            </a:p>
          </p:txBody>
        </p:sp>
        <p:sp>
          <p:nvSpPr>
            <p:cNvPr id="16" name="TextBox 15"/>
            <p:cNvSpPr txBox="1"/>
            <p:nvPr/>
          </p:nvSpPr>
          <p:spPr>
            <a:xfrm rot="19372165">
              <a:off x="3594364" y="1971022"/>
              <a:ext cx="1224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/>
                <a:t>SNU-216</a:t>
              </a:r>
              <a:endParaRPr lang="ko-KR" altLang="en-US" sz="1200" dirty="0"/>
            </a:p>
          </p:txBody>
        </p:sp>
        <p:sp>
          <p:nvSpPr>
            <p:cNvPr id="17" name="TextBox 16"/>
            <p:cNvSpPr txBox="1"/>
            <p:nvPr/>
          </p:nvSpPr>
          <p:spPr>
            <a:xfrm rot="19372165">
              <a:off x="3873440" y="1989676"/>
              <a:ext cx="1224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/>
                <a:t>SNU-16</a:t>
              </a:r>
              <a:endParaRPr lang="ko-KR" altLang="en-US" sz="1200" dirty="0"/>
            </a:p>
          </p:txBody>
        </p:sp>
        <p:sp>
          <p:nvSpPr>
            <p:cNvPr id="18" name="TextBox 17"/>
            <p:cNvSpPr txBox="1"/>
            <p:nvPr/>
          </p:nvSpPr>
          <p:spPr>
            <a:xfrm rot="19372165">
              <a:off x="4120986" y="1989676"/>
              <a:ext cx="1224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/>
                <a:t>AGS</a:t>
              </a:r>
              <a:endParaRPr lang="ko-KR" altLang="en-US" sz="1200" dirty="0"/>
            </a:p>
          </p:txBody>
        </p:sp>
        <p:sp>
          <p:nvSpPr>
            <p:cNvPr id="19" name="TextBox 18"/>
            <p:cNvSpPr txBox="1"/>
            <p:nvPr/>
          </p:nvSpPr>
          <p:spPr>
            <a:xfrm rot="19372165">
              <a:off x="4409018" y="1971022"/>
              <a:ext cx="1224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/>
                <a:t>SNU-620</a:t>
              </a:r>
              <a:endParaRPr lang="ko-KR" altLang="en-US" sz="1200" dirty="0"/>
            </a:p>
          </p:txBody>
        </p:sp>
        <p:pic>
          <p:nvPicPr>
            <p:cNvPr id="23" name="Picture 3" descr="D:\느시\HYUN\할미새사촌\Data\2017젠더_위암(승연)\180104_12종세포확인(재)\2018-01-16_13-45-05 (1)\2018-01-16_13-45-05_8bit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940" t="59026" r="27726" b="35258"/>
            <a:stretch/>
          </p:blipFill>
          <p:spPr bwMode="auto">
            <a:xfrm>
              <a:off x="1870836" y="3540651"/>
              <a:ext cx="3186254" cy="361885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4" name="Picture 2" descr="D:\느시\HYUN\할미새사촌\Data\2017젠더_위암(승연)\180104_12종세포확인(재)\2018-01-19_15-04-08 (1)\2018-01-19_15-04-08_8bit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25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331" t="46595" r="18623" b="48695"/>
            <a:stretch/>
          </p:blipFill>
          <p:spPr bwMode="auto">
            <a:xfrm>
              <a:off x="1870836" y="3070092"/>
              <a:ext cx="3169794" cy="361885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22" name="TextBox 21"/>
          <p:cNvSpPr txBox="1"/>
          <p:nvPr/>
        </p:nvSpPr>
        <p:spPr>
          <a:xfrm>
            <a:off x="129632" y="5943139"/>
            <a:ext cx="6614227" cy="300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Expression of estrogen receptors in various gastric cancer cell lines</a:t>
            </a:r>
          </a:p>
          <a:p>
            <a:pPr algn="just">
              <a:lnSpc>
                <a:spcPct val="150000"/>
              </a:lnSpc>
            </a:pP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Twelve gastric cancer cell lines were originated from male (6 cells from left) and female (6 cells from right). These cells also classified two types, intestinal adenocarcinoma including NCI-N87, SNU-638, MKN-1, MKN-28, SNU-216 and AGS, and diffuse type including SNU-484, SNU-1, KATO III, SNU-16, SNU-620, SNU-5. Protein levels of estrogen receptor (ER) </a:t>
            </a:r>
            <a:r>
              <a:rPr lang="el-GR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l-GR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 were measured by western blotting. </a:t>
            </a:r>
            <a:endParaRPr lang="ko-KR" altLang="en-US" sz="1400" dirty="0">
              <a:latin typeface="Arial" panose="020B0604020202020204" pitchFamily="34" charset="0"/>
              <a:ea typeface="함초롬바탕" panose="02030604000101010101" pitchFamily="18" charset="-127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09430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98F4DB69-4AE6-40AC-B6F7-F290E9F6444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2218480"/>
              </p:ext>
            </p:extLst>
          </p:nvPr>
        </p:nvGraphicFramePr>
        <p:xfrm>
          <a:off x="548677" y="910155"/>
          <a:ext cx="5278268" cy="82708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234022">
                  <a:extLst>
                    <a:ext uri="{9D8B030D-6E8A-4147-A177-3AD203B41FA5}">
                      <a16:colId xmlns:a16="http://schemas.microsoft.com/office/drawing/2014/main" val="4165629486"/>
                    </a:ext>
                  </a:extLst>
                </a:gridCol>
                <a:gridCol w="1014494">
                  <a:extLst>
                    <a:ext uri="{9D8B030D-6E8A-4147-A177-3AD203B41FA5}">
                      <a16:colId xmlns:a16="http://schemas.microsoft.com/office/drawing/2014/main" val="2591187017"/>
                    </a:ext>
                  </a:extLst>
                </a:gridCol>
                <a:gridCol w="1014494">
                  <a:extLst>
                    <a:ext uri="{9D8B030D-6E8A-4147-A177-3AD203B41FA5}">
                      <a16:colId xmlns:a16="http://schemas.microsoft.com/office/drawing/2014/main" val="676562457"/>
                    </a:ext>
                  </a:extLst>
                </a:gridCol>
                <a:gridCol w="1015258">
                  <a:extLst>
                    <a:ext uri="{9D8B030D-6E8A-4147-A177-3AD203B41FA5}">
                      <a16:colId xmlns:a16="http://schemas.microsoft.com/office/drawing/2014/main" val="55572440"/>
                    </a:ext>
                  </a:extLst>
                </a:gridCol>
              </a:tblGrid>
              <a:tr h="319312">
                <a:tc>
                  <a:txBody>
                    <a:bodyPr/>
                    <a:lstStyle/>
                    <a:p>
                      <a:pPr algn="ctr" eaLnBrk="0" hangingPunct="0">
                        <a:lnSpc>
                          <a:spcPts val="13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ysClr val="windowText" lastClr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ko-KR" sz="1100" i="1" dirty="0">
                        <a:solidFill>
                          <a:sysClr val="windowText" lastClr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 hangingPunct="0">
                        <a:lnSpc>
                          <a:spcPts val="13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ysClr val="windowText" lastClr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ontrol</a:t>
                      </a:r>
                      <a:endParaRPr lang="ko-KR" sz="1100" i="1" dirty="0">
                        <a:solidFill>
                          <a:sysClr val="windowText" lastClr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 hangingPunct="0">
                        <a:lnSpc>
                          <a:spcPts val="13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ysClr val="windowText" lastClr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OVX</a:t>
                      </a:r>
                      <a:endParaRPr lang="ko-KR" sz="1100" i="1">
                        <a:solidFill>
                          <a:sysClr val="windowText" lastClr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 hangingPunct="0">
                        <a:lnSpc>
                          <a:spcPts val="13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ysClr val="windowText" lastClr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OVX + E2</a:t>
                      </a:r>
                      <a:endParaRPr lang="ko-KR" sz="1100" i="1">
                        <a:solidFill>
                          <a:sysClr val="windowText" lastClr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4077031"/>
                  </a:ext>
                </a:extLst>
              </a:tr>
              <a:tr h="253887">
                <a:tc>
                  <a:txBody>
                    <a:bodyPr/>
                    <a:lstStyle/>
                    <a:p>
                      <a:pPr algn="ctr" eaLnBrk="0" hangingPunct="0">
                        <a:lnSpc>
                          <a:spcPts val="13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ysClr val="windowText" lastClr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verage estrogen conc. (</a:t>
                      </a:r>
                      <a:r>
                        <a:rPr lang="en-US" sz="1100" dirty="0" err="1">
                          <a:solidFill>
                            <a:sysClr val="windowText" lastClr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g</a:t>
                      </a:r>
                      <a:r>
                        <a:rPr lang="en-US" sz="1100" dirty="0">
                          <a:solidFill>
                            <a:sysClr val="windowText" lastClr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/mL)</a:t>
                      </a:r>
                      <a:endParaRPr lang="ko-KR" sz="1100" i="1" dirty="0">
                        <a:solidFill>
                          <a:sysClr val="windowText" lastClr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 hangingPunct="0">
                        <a:lnSpc>
                          <a:spcPts val="13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ysClr val="windowText" lastClr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32.1</a:t>
                      </a:r>
                      <a:endParaRPr lang="ko-KR" sz="1100" i="1">
                        <a:solidFill>
                          <a:sysClr val="windowText" lastClr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 hangingPunct="0">
                        <a:lnSpc>
                          <a:spcPts val="13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ysClr val="windowText" lastClr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5</a:t>
                      </a:r>
                      <a:endParaRPr lang="ko-KR" sz="1100" i="1" dirty="0">
                        <a:solidFill>
                          <a:sysClr val="windowText" lastClr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 hangingPunct="0">
                        <a:lnSpc>
                          <a:spcPts val="13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ysClr val="windowText" lastClr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95.4</a:t>
                      </a:r>
                      <a:endParaRPr lang="ko-KR" sz="1100" i="1" dirty="0">
                        <a:solidFill>
                          <a:sysClr val="windowText" lastClr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7525836"/>
                  </a:ext>
                </a:extLst>
              </a:tr>
              <a:tr h="253887">
                <a:tc gridSpan="4">
                  <a:txBody>
                    <a:bodyPr/>
                    <a:lstStyle/>
                    <a:p>
                      <a:pPr eaLnBrk="0" hangingPunct="0">
                        <a:lnSpc>
                          <a:spcPts val="13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ysClr val="windowText" lastClr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* E2, 17β-estradiol</a:t>
                      </a:r>
                      <a:endParaRPr lang="ko-KR" sz="1100" i="1" dirty="0">
                        <a:solidFill>
                          <a:sysClr val="windowText" lastClr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39102027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7E7B9770-BD38-4C00-BFB1-238E014AEC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4927" y="506665"/>
            <a:ext cx="35741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</a:rPr>
              <a:t>A</a:t>
            </a:r>
          </a:p>
        </p:txBody>
      </p:sp>
      <p:grpSp>
        <p:nvGrpSpPr>
          <p:cNvPr id="4" name="그룹 3">
            <a:extLst>
              <a:ext uri="{FF2B5EF4-FFF2-40B4-BE49-F238E27FC236}">
                <a16:creationId xmlns:a16="http://schemas.microsoft.com/office/drawing/2014/main" id="{60AFFBA8-5418-493B-81A5-829220BEB7A7}"/>
              </a:ext>
            </a:extLst>
          </p:cNvPr>
          <p:cNvGrpSpPr/>
          <p:nvPr/>
        </p:nvGrpSpPr>
        <p:grpSpPr>
          <a:xfrm>
            <a:off x="961973" y="2163287"/>
            <a:ext cx="4002713" cy="1728192"/>
            <a:chOff x="496018" y="4129717"/>
            <a:chExt cx="7136362" cy="2710186"/>
          </a:xfrm>
        </p:grpSpPr>
        <p:pic>
          <p:nvPicPr>
            <p:cNvPr id="5" name="Picture 2" descr="C:\Users\user\Desktop\KakaoTalk_20180615_184426415.jpg">
              <a:extLst>
                <a:ext uri="{FF2B5EF4-FFF2-40B4-BE49-F238E27FC236}">
                  <a16:creationId xmlns:a16="http://schemas.microsoft.com/office/drawing/2014/main" id="{18E1CD22-8A47-4EF8-A558-163AB888E12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473" t="5885" r="24972" b="16071"/>
            <a:stretch/>
          </p:blipFill>
          <p:spPr bwMode="auto">
            <a:xfrm rot="16200000">
              <a:off x="3406974" y="1218761"/>
              <a:ext cx="1314450" cy="713636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3" descr="C:\Users\user\Desktop\KakaoTalk_20180615_184541460.jpg">
              <a:extLst>
                <a:ext uri="{FF2B5EF4-FFF2-40B4-BE49-F238E27FC236}">
                  <a16:creationId xmlns:a16="http://schemas.microsoft.com/office/drawing/2014/main" id="{ABF509CB-DB94-4F57-8033-64D572E98FE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321" t="27675" r="72038" b="40579"/>
            <a:stretch/>
          </p:blipFill>
          <p:spPr bwMode="auto">
            <a:xfrm>
              <a:off x="784050" y="5027746"/>
              <a:ext cx="1314003" cy="1330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4" descr="C:\Users\user\Desktop\KakaoTalk_20180615_184619201.jpg">
              <a:extLst>
                <a:ext uri="{FF2B5EF4-FFF2-40B4-BE49-F238E27FC236}">
                  <a16:creationId xmlns:a16="http://schemas.microsoft.com/office/drawing/2014/main" id="{4ADF0E9D-1D19-4F8F-B6BC-F0AD0A83E36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894" t="57086" r="4930" b="22884"/>
            <a:stretch/>
          </p:blipFill>
          <p:spPr bwMode="auto">
            <a:xfrm flipH="1" flipV="1">
              <a:off x="701591" y="5873023"/>
              <a:ext cx="2451902" cy="91548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3" descr="C:\Users\user\Desktop\KakaoTalk_20180615_184541460.jpg">
              <a:extLst>
                <a:ext uri="{FF2B5EF4-FFF2-40B4-BE49-F238E27FC236}">
                  <a16:creationId xmlns:a16="http://schemas.microsoft.com/office/drawing/2014/main" id="{B5111498-602F-4914-AB2C-7F68EA8FA59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75" t="27675" r="64713" b="40579"/>
            <a:stretch/>
          </p:blipFill>
          <p:spPr bwMode="auto">
            <a:xfrm>
              <a:off x="2339701" y="5000666"/>
              <a:ext cx="619125" cy="1330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" name="Picture 3" descr="C:\Users\user\Desktop\KakaoTalk_20180615_184541460.jpg">
              <a:extLst>
                <a:ext uri="{FF2B5EF4-FFF2-40B4-BE49-F238E27FC236}">
                  <a16:creationId xmlns:a16="http://schemas.microsoft.com/office/drawing/2014/main" id="{184DAC65-930F-40F6-952C-D2355D872DC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469" t="27675" r="55158" b="40579"/>
            <a:stretch/>
          </p:blipFill>
          <p:spPr bwMode="auto">
            <a:xfrm>
              <a:off x="3232322" y="5036550"/>
              <a:ext cx="698153" cy="1330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" name="Picture 3" descr="C:\Users\user\Desktop\KakaoTalk_20180615_184541460.jpg">
              <a:extLst>
                <a:ext uri="{FF2B5EF4-FFF2-40B4-BE49-F238E27FC236}">
                  <a16:creationId xmlns:a16="http://schemas.microsoft.com/office/drawing/2014/main" id="{EAB176EE-1A39-44F3-831D-373640E679C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481" t="27675" r="45174" b="40579"/>
            <a:stretch/>
          </p:blipFill>
          <p:spPr bwMode="auto">
            <a:xfrm>
              <a:off x="4082108" y="5037324"/>
              <a:ext cx="621584" cy="1330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Picture 3" descr="C:\Users\user\Desktop\KakaoTalk_20180615_184541460.jpg">
              <a:extLst>
                <a:ext uri="{FF2B5EF4-FFF2-40B4-BE49-F238E27FC236}">
                  <a16:creationId xmlns:a16="http://schemas.microsoft.com/office/drawing/2014/main" id="{9F5208A4-AAF2-4EC2-9722-598AC7A47AE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495" t="27675" r="38160" b="40579"/>
            <a:stretch/>
          </p:blipFill>
          <p:spPr bwMode="auto">
            <a:xfrm>
              <a:off x="4805722" y="5012665"/>
              <a:ext cx="621585" cy="1330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3" descr="C:\Users\user\Desktop\KakaoTalk_20180615_184541460.jpg">
              <a:extLst>
                <a:ext uri="{FF2B5EF4-FFF2-40B4-BE49-F238E27FC236}">
                  <a16:creationId xmlns:a16="http://schemas.microsoft.com/office/drawing/2014/main" id="{CC7F9C82-E22D-4937-9EB6-ACF82834A48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907" t="27675" r="31561" b="40579"/>
            <a:stretch/>
          </p:blipFill>
          <p:spPr bwMode="auto">
            <a:xfrm>
              <a:off x="5896618" y="5046080"/>
              <a:ext cx="412077" cy="1330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" name="Picture 3" descr="C:\Users\user\Desktop\KakaoTalk_20180615_184541460.jpg">
              <a:extLst>
                <a:ext uri="{FF2B5EF4-FFF2-40B4-BE49-F238E27FC236}">
                  <a16:creationId xmlns:a16="http://schemas.microsoft.com/office/drawing/2014/main" id="{91706BEB-771F-4A40-A93E-D4FC489A774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440" t="27675" r="23005" b="40579"/>
            <a:stretch/>
          </p:blipFill>
          <p:spPr bwMode="auto">
            <a:xfrm>
              <a:off x="6845862" y="5046080"/>
              <a:ext cx="637214" cy="1330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" name="Picture 4" descr="C:\Users\user\Desktop\KakaoTalk_20180615_184619201.jpg">
              <a:extLst>
                <a:ext uri="{FF2B5EF4-FFF2-40B4-BE49-F238E27FC236}">
                  <a16:creationId xmlns:a16="http://schemas.microsoft.com/office/drawing/2014/main" id="{B4B5EEBF-FAC6-4A8D-9FFE-D1CB0323B70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967" t="57086" r="34090" b="22884"/>
            <a:stretch/>
          </p:blipFill>
          <p:spPr bwMode="auto">
            <a:xfrm flipH="1" flipV="1">
              <a:off x="3160314" y="5868229"/>
              <a:ext cx="726679" cy="91548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" name="Picture 4" descr="C:\Users\user\Desktop\KakaoTalk_20180615_184619201.jpg">
              <a:extLst>
                <a:ext uri="{FF2B5EF4-FFF2-40B4-BE49-F238E27FC236}">
                  <a16:creationId xmlns:a16="http://schemas.microsoft.com/office/drawing/2014/main" id="{704EF2C0-02B5-4CFD-B219-683B2A68FADB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029" t="57086" r="44851" b="22884"/>
            <a:stretch/>
          </p:blipFill>
          <p:spPr bwMode="auto">
            <a:xfrm flipH="1" flipV="1">
              <a:off x="4168426" y="5866465"/>
              <a:ext cx="741040" cy="91548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" name="Picture 4" descr="C:\Users\user\Desktop\KakaoTalk_20180615_184619201.jpg">
              <a:extLst>
                <a:ext uri="{FF2B5EF4-FFF2-40B4-BE49-F238E27FC236}">
                  <a16:creationId xmlns:a16="http://schemas.microsoft.com/office/drawing/2014/main" id="{1AB1FB0A-E739-4FDF-B52A-4EBF6A6B523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212" t="57086" r="61746" b="22884"/>
            <a:stretch/>
          </p:blipFill>
          <p:spPr bwMode="auto">
            <a:xfrm flipH="1" flipV="1">
              <a:off x="5827686" y="5716438"/>
              <a:ext cx="1709756" cy="91548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" name="Picture 4" descr="C:\Users\user\Desktop\KakaoTalk_20180615_184619201.jpg">
              <a:extLst>
                <a:ext uri="{FF2B5EF4-FFF2-40B4-BE49-F238E27FC236}">
                  <a16:creationId xmlns:a16="http://schemas.microsoft.com/office/drawing/2014/main" id="{3BE2FB41-5A04-499D-833D-65A0FF0A804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761" t="57086" r="53045" b="22884"/>
            <a:stretch/>
          </p:blipFill>
          <p:spPr bwMode="auto">
            <a:xfrm flipH="1" flipV="1">
              <a:off x="4950099" y="5771812"/>
              <a:ext cx="665795" cy="91548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8" name="Picture 2" descr="C:\Users\user\Desktop\KakaoTalk_20180615_184426415.jpg">
              <a:extLst>
                <a:ext uri="{FF2B5EF4-FFF2-40B4-BE49-F238E27FC236}">
                  <a16:creationId xmlns:a16="http://schemas.microsoft.com/office/drawing/2014/main" id="{31915354-7772-4B1C-90AB-0296660C80B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250" t="8098" r="32710" b="90079"/>
            <a:stretch/>
          </p:blipFill>
          <p:spPr bwMode="auto">
            <a:xfrm rot="5400000">
              <a:off x="7176373" y="6114183"/>
              <a:ext cx="722139" cy="16668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" name="Picture 4" descr="C:\Users\user\Desktop\KakaoTalk_20180615_184619201.jpg">
              <a:extLst>
                <a:ext uri="{FF2B5EF4-FFF2-40B4-BE49-F238E27FC236}">
                  <a16:creationId xmlns:a16="http://schemas.microsoft.com/office/drawing/2014/main" id="{14DD9822-1A2B-4A24-878D-A686DBFEDA1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179" t="57086" r="10078" b="22884"/>
            <a:stretch/>
          </p:blipFill>
          <p:spPr bwMode="auto">
            <a:xfrm flipH="1" flipV="1">
              <a:off x="1143849" y="5924417"/>
              <a:ext cx="954202" cy="91548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20" name="TextBox 26">
            <a:extLst>
              <a:ext uri="{FF2B5EF4-FFF2-40B4-BE49-F238E27FC236}">
                <a16:creationId xmlns:a16="http://schemas.microsoft.com/office/drawing/2014/main" id="{3F60AAA8-CFF7-4C11-A359-18A053AD4F4C}"/>
              </a:ext>
            </a:extLst>
          </p:cNvPr>
          <p:cNvSpPr txBox="1"/>
          <p:nvPr/>
        </p:nvSpPr>
        <p:spPr>
          <a:xfrm>
            <a:off x="548677" y="2498722"/>
            <a:ext cx="8269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>
                <a:solidFill>
                  <a:srgbClr val="000000"/>
                </a:solidFill>
                <a:latin typeface="Arial"/>
                <a:ea typeface="맑은 고딕"/>
                <a:cs typeface="굴림"/>
              </a:rPr>
              <a:t>Control</a:t>
            </a:r>
            <a:endParaRPr lang="ko-KR" altLang="en-US" sz="2000" dirty="0">
              <a:latin typeface="굴림"/>
              <a:cs typeface="굴림"/>
            </a:endParaRPr>
          </a:p>
        </p:txBody>
      </p:sp>
      <p:sp>
        <p:nvSpPr>
          <p:cNvPr id="21" name="TextBox 27">
            <a:extLst>
              <a:ext uri="{FF2B5EF4-FFF2-40B4-BE49-F238E27FC236}">
                <a16:creationId xmlns:a16="http://schemas.microsoft.com/office/drawing/2014/main" id="{4436C0D6-D67F-48A1-B813-9FE623126BCD}"/>
              </a:ext>
            </a:extLst>
          </p:cNvPr>
          <p:cNvSpPr txBox="1"/>
          <p:nvPr/>
        </p:nvSpPr>
        <p:spPr>
          <a:xfrm>
            <a:off x="775214" y="2970534"/>
            <a:ext cx="6004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>
                <a:solidFill>
                  <a:srgbClr val="000000"/>
                </a:solidFill>
                <a:latin typeface="Arial"/>
                <a:ea typeface="맑은 고딕"/>
                <a:cs typeface="굴림"/>
              </a:rPr>
              <a:t>OVX</a:t>
            </a:r>
            <a:endParaRPr lang="ko-KR" altLang="en-US" sz="2000" dirty="0">
              <a:latin typeface="굴림"/>
              <a:cs typeface="굴림"/>
            </a:endParaRPr>
          </a:p>
        </p:txBody>
      </p:sp>
      <p:sp>
        <p:nvSpPr>
          <p:cNvPr id="22" name="TextBox 28">
            <a:extLst>
              <a:ext uri="{FF2B5EF4-FFF2-40B4-BE49-F238E27FC236}">
                <a16:creationId xmlns:a16="http://schemas.microsoft.com/office/drawing/2014/main" id="{48AE2FF8-9C63-442E-AAEE-49A245823677}"/>
              </a:ext>
            </a:extLst>
          </p:cNvPr>
          <p:cNvSpPr txBox="1"/>
          <p:nvPr/>
        </p:nvSpPr>
        <p:spPr>
          <a:xfrm>
            <a:off x="582125" y="3438959"/>
            <a:ext cx="793496" cy="35274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sz="1200" dirty="0">
                <a:solidFill>
                  <a:srgbClr val="000000"/>
                </a:solidFill>
                <a:latin typeface="Arial"/>
                <a:ea typeface="맑은 고딕"/>
                <a:cs typeface="굴림"/>
              </a:rPr>
              <a:t>OVX+E2</a:t>
            </a:r>
            <a:endParaRPr lang="ko-KR" altLang="en-US" sz="2000" dirty="0">
              <a:latin typeface="굴림"/>
              <a:cs typeface="굴림"/>
            </a:endParaRPr>
          </a:p>
        </p:txBody>
      </p:sp>
      <p:pic>
        <p:nvPicPr>
          <p:cNvPr id="23" name="그림 22">
            <a:extLst>
              <a:ext uri="{FF2B5EF4-FFF2-40B4-BE49-F238E27FC236}">
                <a16:creationId xmlns:a16="http://schemas.microsoft.com/office/drawing/2014/main" id="{186A8E44-97B8-4F2F-B891-850272323E27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82125" y="4153862"/>
            <a:ext cx="2353523" cy="2400313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31838DA8-EFED-48EA-B159-5BF51D2AFD5E}"/>
              </a:ext>
            </a:extLst>
          </p:cNvPr>
          <p:cNvSpPr txBox="1"/>
          <p:nvPr/>
        </p:nvSpPr>
        <p:spPr>
          <a:xfrm>
            <a:off x="51889" y="6980714"/>
            <a:ext cx="675422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The effect of estrogen in ovariectomized mice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fter the final measurement of tumor volume, the blood was taken from these mice, and the isolated uterus weight was measured. </a:t>
            </a:r>
          </a:p>
          <a:p>
            <a:r>
              <a:rPr lang="en-US" altLang="ko-KR" sz="14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. </a:t>
            </a:r>
            <a:r>
              <a:rPr lang="en-US" altLang="ko-KR" sz="14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otal estrogen concentration in the blood. </a:t>
            </a:r>
            <a:r>
              <a:rPr lang="en-US" altLang="ko-KR" sz="14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.</a:t>
            </a:r>
            <a:r>
              <a:rPr lang="en-US" altLang="ko-KR" sz="14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Photograph of uterus.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 Uterus weight. Data are presented as the mean ± SD (n = 7/group). One-way ANOVA; *, p &lt; 0.05; ***, p &lt; 0.001.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1">
            <a:extLst>
              <a:ext uri="{FF2B5EF4-FFF2-40B4-BE49-F238E27FC236}">
                <a16:creationId xmlns:a16="http://schemas.microsoft.com/office/drawing/2014/main" id="{FF7E7B72-7146-49DB-83FC-D4694CCCA3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4927" y="2023227"/>
            <a:ext cx="35741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</a:rPr>
              <a:t>B</a:t>
            </a:r>
          </a:p>
        </p:txBody>
      </p:sp>
      <p:sp>
        <p:nvSpPr>
          <p:cNvPr id="29" name="Rectangle 1">
            <a:extLst>
              <a:ext uri="{FF2B5EF4-FFF2-40B4-BE49-F238E27FC236}">
                <a16:creationId xmlns:a16="http://schemas.microsoft.com/office/drawing/2014/main" id="{3E617233-00A1-430F-8ADB-05147236A1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4927" y="4101301"/>
            <a:ext cx="35741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191323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92862322-3ED9-4FDE-B265-2E0E40D514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4639775"/>
              </p:ext>
            </p:extLst>
          </p:nvPr>
        </p:nvGraphicFramePr>
        <p:xfrm>
          <a:off x="421554" y="987527"/>
          <a:ext cx="3767387" cy="187587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18457">
                  <a:extLst>
                    <a:ext uri="{9D8B030D-6E8A-4147-A177-3AD203B41FA5}">
                      <a16:colId xmlns:a16="http://schemas.microsoft.com/office/drawing/2014/main" val="868461161"/>
                    </a:ext>
                  </a:extLst>
                </a:gridCol>
                <a:gridCol w="2248930">
                  <a:extLst>
                    <a:ext uri="{9D8B030D-6E8A-4147-A177-3AD203B41FA5}">
                      <a16:colId xmlns:a16="http://schemas.microsoft.com/office/drawing/2014/main" val="2195227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Gene</a:t>
                      </a:r>
                      <a:endParaRPr lang="ko-KR" sz="1050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fymetrix ID </a:t>
                      </a:r>
                      <a:endParaRPr lang="ko-KR" sz="1050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5050489"/>
                  </a:ext>
                </a:extLst>
              </a:tr>
              <a:tr h="27702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IFNGR2</a:t>
                      </a:r>
                      <a:endParaRPr lang="ko-KR" sz="1050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642_at</a:t>
                      </a:r>
                      <a:endParaRPr lang="ko-KR" sz="1050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1990794"/>
                  </a:ext>
                </a:extLst>
              </a:tr>
              <a:tr h="282338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IQCE</a:t>
                      </a:r>
                      <a:endParaRPr lang="ko-KR" sz="1050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4202_at</a:t>
                      </a:r>
                      <a:endParaRPr lang="ko-KR" sz="1050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08450046"/>
                  </a:ext>
                </a:extLst>
              </a:tr>
              <a:tr h="282338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TRPM4</a:t>
                      </a:r>
                      <a:endParaRPr lang="ko-KR" sz="1050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9360_at</a:t>
                      </a:r>
                      <a:endParaRPr lang="ko-KR" sz="1050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9227512"/>
                  </a:ext>
                </a:extLst>
              </a:tr>
              <a:tr h="27702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SLX4</a:t>
                      </a:r>
                      <a:endParaRPr lang="ko-KR" sz="1050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2147_at</a:t>
                      </a:r>
                      <a:endParaRPr lang="ko-KR" sz="1050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9449369"/>
                  </a:ext>
                </a:extLst>
              </a:tr>
              <a:tr h="282338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GPER</a:t>
                      </a:r>
                      <a:endParaRPr lang="ko-KR" sz="1050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0640_s_at</a:t>
                      </a:r>
                      <a:endParaRPr lang="ko-KR" sz="1050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4386967"/>
                  </a:ext>
                </a:extLst>
              </a:tr>
              <a:tr h="282338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ARTN</a:t>
                      </a:r>
                      <a:endParaRPr lang="ko-KR" sz="1050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7675_x_at</a:t>
                      </a:r>
                      <a:endParaRPr lang="ko-KR" sz="1050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9944807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F18B2EA4-C686-49F3-9930-6B6A343FCC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310" y="476664"/>
            <a:ext cx="6559379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upplementary Table 1. </a:t>
            </a:r>
            <a:r>
              <a:rPr kumimoji="0" lang="en-US" altLang="ko-KR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ffymetrix ID used in Kaplan-Meier plotter </a:t>
            </a:r>
            <a:endParaRPr kumimoji="0" lang="en-US" altLang="ko-KR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ko-KR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04554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061913CB-3DD5-4337-B163-066316BC2A28}"/>
              </a:ext>
            </a:extLst>
          </p:cNvPr>
          <p:cNvSpPr txBox="1"/>
          <p:nvPr/>
        </p:nvSpPr>
        <p:spPr>
          <a:xfrm>
            <a:off x="86499" y="602771"/>
            <a:ext cx="6626094" cy="5146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700"/>
              </a:lnSpc>
            </a:pPr>
            <a:r>
              <a:rPr lang="en-US" altLang="ko-KR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upplementary Table 2.</a:t>
            </a:r>
            <a:r>
              <a:rPr lang="en-US" altLang="ko-KR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4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ifferentially expressed genes in SNU-16-derived tumor tissues obtained from ovariectomized xenograft model  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B4CBCAE-D962-472E-AB85-DEF601BBDB35}"/>
              </a:ext>
            </a:extLst>
          </p:cNvPr>
          <p:cNvSpPr txBox="1"/>
          <p:nvPr/>
        </p:nvSpPr>
        <p:spPr>
          <a:xfrm>
            <a:off x="-33552" y="4572000"/>
            <a:ext cx="6746145" cy="73270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700"/>
              </a:lnSpc>
            </a:pPr>
            <a:r>
              <a:rPr lang="en-US" altLang="ko-KR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umor tissues obtained from ovariectomized xenograft model were analyzed by total RNA sequencing. </a:t>
            </a:r>
            <a:r>
              <a:rPr lang="en-US" altLang="ko-KR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ased on the Fragments Per Kilobase Million (FPKM) value of each gene, DEGs </a:t>
            </a:r>
            <a:r>
              <a:rPr lang="en-US" altLang="ko-KR" sz="14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as selected. Significance, </a:t>
            </a:r>
            <a:r>
              <a:rPr lang="en-US" altLang="ko-KR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 ≤ 0.00005 and q &lt; 0.05. </a:t>
            </a:r>
            <a:endParaRPr lang="ko-KR" altLang="ko-KR" sz="1400" dirty="0">
              <a:solidFill>
                <a:srgbClr val="000000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graphicFrame>
        <p:nvGraphicFramePr>
          <p:cNvPr id="23" name="표 22">
            <a:extLst>
              <a:ext uri="{FF2B5EF4-FFF2-40B4-BE49-F238E27FC236}">
                <a16:creationId xmlns:a16="http://schemas.microsoft.com/office/drawing/2014/main" id="{59098153-0139-45F1-B912-82485621290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67079"/>
              </p:ext>
            </p:extLst>
          </p:nvPr>
        </p:nvGraphicFramePr>
        <p:xfrm>
          <a:off x="241892" y="1383957"/>
          <a:ext cx="6104238" cy="306284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12938">
                  <a:extLst>
                    <a:ext uri="{9D8B030D-6E8A-4147-A177-3AD203B41FA5}">
                      <a16:colId xmlns:a16="http://schemas.microsoft.com/office/drawing/2014/main" val="104494904"/>
                    </a:ext>
                  </a:extLst>
                </a:gridCol>
                <a:gridCol w="928018">
                  <a:extLst>
                    <a:ext uri="{9D8B030D-6E8A-4147-A177-3AD203B41FA5}">
                      <a16:colId xmlns:a16="http://schemas.microsoft.com/office/drawing/2014/main" val="1334348801"/>
                    </a:ext>
                  </a:extLst>
                </a:gridCol>
                <a:gridCol w="928018">
                  <a:extLst>
                    <a:ext uri="{9D8B030D-6E8A-4147-A177-3AD203B41FA5}">
                      <a16:colId xmlns:a16="http://schemas.microsoft.com/office/drawing/2014/main" val="4233166940"/>
                    </a:ext>
                  </a:extLst>
                </a:gridCol>
                <a:gridCol w="928018">
                  <a:extLst>
                    <a:ext uri="{9D8B030D-6E8A-4147-A177-3AD203B41FA5}">
                      <a16:colId xmlns:a16="http://schemas.microsoft.com/office/drawing/2014/main" val="3809737737"/>
                    </a:ext>
                  </a:extLst>
                </a:gridCol>
                <a:gridCol w="856644">
                  <a:extLst>
                    <a:ext uri="{9D8B030D-6E8A-4147-A177-3AD203B41FA5}">
                      <a16:colId xmlns:a16="http://schemas.microsoft.com/office/drawing/2014/main" val="1596076360"/>
                    </a:ext>
                  </a:extLst>
                </a:gridCol>
                <a:gridCol w="1050602">
                  <a:extLst>
                    <a:ext uri="{9D8B030D-6E8A-4147-A177-3AD203B41FA5}">
                      <a16:colId xmlns:a16="http://schemas.microsoft.com/office/drawing/2014/main" val="3310859822"/>
                    </a:ext>
                  </a:extLst>
                </a:gridCol>
              </a:tblGrid>
              <a:tr h="227402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Gene</a:t>
                      </a:r>
                      <a:endParaRPr lang="ko-KR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FPKM 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p-valu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q-valu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0424788"/>
                  </a:ext>
                </a:extLst>
              </a:tr>
              <a:tr h="23254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Control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OVX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OVX+E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81855386"/>
                  </a:ext>
                </a:extLst>
              </a:tr>
              <a:tr h="2366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i="1" u="none" strike="noStrike" dirty="0">
                          <a:effectLst/>
                        </a:rPr>
                        <a:t>CACNA2D4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0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0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1.45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.0001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.044275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34668315"/>
                  </a:ext>
                </a:extLst>
              </a:tr>
              <a:tr h="2366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i="1" u="none" strike="noStrike" dirty="0">
                          <a:effectLst/>
                        </a:rPr>
                        <a:t>PLP1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0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1.63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.00005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.02695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2075869"/>
                  </a:ext>
                </a:extLst>
              </a:tr>
              <a:tr h="2366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i="1" u="none" strike="noStrike" dirty="0">
                          <a:effectLst/>
                        </a:rPr>
                        <a:t>ARTN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1.77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.00005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.02695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7162424"/>
                  </a:ext>
                </a:extLst>
              </a:tr>
              <a:tr h="2366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i="1" u="none" strike="noStrike" dirty="0">
                          <a:effectLst/>
                        </a:rPr>
                        <a:t>EPB41L3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2.24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.00005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.02695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9091163"/>
                  </a:ext>
                </a:extLst>
              </a:tr>
              <a:tr h="2366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i="1" u="none" strike="noStrike" dirty="0">
                          <a:effectLst/>
                        </a:rPr>
                        <a:t>NTNG1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6.05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.00005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.02695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9164072"/>
                  </a:ext>
                </a:extLst>
              </a:tr>
              <a:tr h="2366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i="1" u="none" strike="noStrike" dirty="0">
                          <a:effectLst/>
                        </a:rPr>
                        <a:t>ITM2A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4.32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4.96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0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0.00005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.02695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25404634"/>
                  </a:ext>
                </a:extLst>
              </a:tr>
              <a:tr h="2366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i="1" u="none" strike="noStrike" dirty="0">
                          <a:effectLst/>
                        </a:rPr>
                        <a:t>PNCK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1.45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0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0.00005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.02695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70700725"/>
                  </a:ext>
                </a:extLst>
              </a:tr>
              <a:tr h="2366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i="1" u="none" strike="noStrike" dirty="0">
                          <a:effectLst/>
                        </a:rPr>
                        <a:t>DLG2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1.37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0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0.00005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0.0475538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566894"/>
                  </a:ext>
                </a:extLst>
              </a:tr>
              <a:tr h="2366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i="1" u="none" strike="noStrike" dirty="0">
                          <a:effectLst/>
                        </a:rPr>
                        <a:t>C14orf93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1.92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3.81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.00005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0.0475538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5805516"/>
                  </a:ext>
                </a:extLst>
              </a:tr>
              <a:tr h="2366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i="1" u="none" strike="noStrike" dirty="0">
                          <a:effectLst/>
                        </a:rPr>
                        <a:t>MT1G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242.64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600.91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1840.77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0.00005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0.02695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5475474"/>
                  </a:ext>
                </a:extLst>
              </a:tr>
              <a:tr h="2366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i="1" u="none" strike="noStrike" dirty="0">
                          <a:effectLst/>
                        </a:rPr>
                        <a:t>HMGCS1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78.77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>
                          <a:effectLst/>
                        </a:rPr>
                        <a:t>51.84</a:t>
                      </a:r>
                      <a:endParaRPr lang="en-US" altLang="ko-KR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14.16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0.00005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u="none" strike="noStrike" dirty="0">
                          <a:effectLst/>
                        </a:rPr>
                        <a:t>0.02695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604653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926945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문서" ma:contentTypeID="0x010100A911167E13001A4BAE19F7E182E6B07C" ma:contentTypeVersion="8" ma:contentTypeDescription="새 문서를 만듭니다." ma:contentTypeScope="" ma:versionID="68a6a68b39a8b36d974c4b445b643317">
  <xsd:schema xmlns:xsd="http://www.w3.org/2001/XMLSchema" xmlns:xs="http://www.w3.org/2001/XMLSchema" xmlns:p="http://schemas.microsoft.com/office/2006/metadata/properties" xmlns:ns3="1493eff7-c7f8-4454-a3ff-fdd01c61b169" xmlns:ns4="815b34b9-f7a3-49ca-bcde-38e627c7f99e" targetNamespace="http://schemas.microsoft.com/office/2006/metadata/properties" ma:root="true" ma:fieldsID="dc6e3fa6609bccdbfb09aa145f12f00e" ns3:_="" ns4:_="">
    <xsd:import namespace="1493eff7-c7f8-4454-a3ff-fdd01c61b169"/>
    <xsd:import namespace="815b34b9-f7a3-49ca-bcde-38e627c7f99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493eff7-c7f8-4454-a3ff-fdd01c61b16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15b34b9-f7a3-49ca-bcde-38e627c7f99e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공유 대상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세부 정보 공유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4" nillable="true" ma:displayName="힌트 해시 공유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콘텐츠 형식"/>
        <xsd:element ref="dc:title" minOccurs="0" maxOccurs="1" ma:index="4" ma:displayName="제목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F0E84287-1DDE-479D-90C4-62498B592D1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493eff7-c7f8-4454-a3ff-fdd01c61b169"/>
    <ds:schemaRef ds:uri="815b34b9-f7a3-49ca-bcde-38e627c7f99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94596DD-CA8F-4F88-AE81-94F910B4D73F}">
  <ds:schemaRefs>
    <ds:schemaRef ds:uri="http://purl.org/dc/terms/"/>
    <ds:schemaRef ds:uri="815b34b9-f7a3-49ca-bcde-38e627c7f99e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schemas.openxmlformats.org/package/2006/metadata/core-properties"/>
    <ds:schemaRef ds:uri="1493eff7-c7f8-4454-a3ff-fdd01c61b169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F51C8EC2-7894-4BE0-8049-C2CC56DCE0AC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3</TotalTime>
  <Words>494</Words>
  <Application>Microsoft Office PowerPoint</Application>
  <PresentationFormat>화면 슬라이드 쇼(4:3)</PresentationFormat>
  <Paragraphs>146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2" baseType="lpstr">
      <vt:lpstr>굴림</vt:lpstr>
      <vt:lpstr>맑은 고딕</vt:lpstr>
      <vt:lpstr>Arial</vt:lpstr>
      <vt:lpstr>Calibri</vt:lpstr>
      <vt:lpstr>Calibri Light</vt:lpstr>
      <vt:lpstr>Palatino Linotype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DS</dc:creator>
  <cp:lastModifiedBy>정주희</cp:lastModifiedBy>
  <cp:revision>17</cp:revision>
  <dcterms:created xsi:type="dcterms:W3CDTF">2020-09-02T01:36:27Z</dcterms:created>
  <dcterms:modified xsi:type="dcterms:W3CDTF">2021-01-02T03:08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911167E13001A4BAE19F7E182E6B07C</vt:lpwstr>
  </property>
</Properties>
</file>